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D80B7-C904-4BEE-B7E8-32655A2E4C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B0DF3-19ED-4331-B3F3-2F7D86CFD5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22AEB-46C0-4FA2-9170-BBF3D9AE00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C60A2-00A3-4B07-8555-AE89DAFD7A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C5DA5-54A9-4B7F-853F-6FB4D499C9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468C3-4901-49B6-96A4-CD913AEF3A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1B281-EFA7-424F-8942-710431E672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21B23-948A-4209-BA90-8E8528CBB6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CA4EE-1637-4BA1-AB6C-8720F0A714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D17DC-7C90-4DD7-BCAC-61956158DD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394FB-A139-4FE4-A6A0-E87C553BD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B3441-5460-47E1-B364-764ADC4A06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0CED62A-AF6B-403A-92CE-C6F37AD1990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B420CFC-2779-4B45-91D5-13780E621B4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8"/>
          <p:cNvSpPr/>
          <p:nvPr/>
        </p:nvSpPr>
        <p:spPr>
          <a:xfrm>
            <a:off x="5576760" y="0"/>
            <a:ext cx="35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ush, et al., Supplemental Figure S6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5"/>
          <p:cNvSpPr/>
          <p:nvPr/>
        </p:nvSpPr>
        <p:spPr>
          <a:xfrm>
            <a:off x="712800" y="5538960"/>
            <a:ext cx="75675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(A) ChIP-Seq global peak overlap between two biological replicates for each condition. (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verage profile of ChIP-Seq peaks in the region from -1000 to +1000 bp around the transcription start site (TSS) of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32" descr="Picture 12"/>
          <p:cNvPicPr/>
          <p:nvPr/>
        </p:nvPicPr>
        <p:blipFill>
          <a:blip r:embed="rId1"/>
          <a:srcRect l="10306" t="0" r="0" b="0"/>
          <a:stretch/>
        </p:blipFill>
        <p:spPr>
          <a:xfrm>
            <a:off x="331920" y="1268280"/>
            <a:ext cx="4532040" cy="36068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0" descr=""/>
          <p:cNvPicPr/>
          <p:nvPr/>
        </p:nvPicPr>
        <p:blipFill>
          <a:blip r:embed="rId2"/>
          <a:stretch/>
        </p:blipFill>
        <p:spPr>
          <a:xfrm>
            <a:off x="5065560" y="1033560"/>
            <a:ext cx="3918240" cy="21016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1" descr=""/>
          <p:cNvPicPr/>
          <p:nvPr/>
        </p:nvPicPr>
        <p:blipFill>
          <a:blip r:embed="rId3"/>
          <a:stretch/>
        </p:blipFill>
        <p:spPr>
          <a:xfrm>
            <a:off x="5040360" y="2989440"/>
            <a:ext cx="3917880" cy="210312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35"/>
          <p:cNvSpPr/>
          <p:nvPr/>
        </p:nvSpPr>
        <p:spPr>
          <a:xfrm>
            <a:off x="333720" y="366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36"/>
          <p:cNvSpPr/>
          <p:nvPr/>
        </p:nvSpPr>
        <p:spPr>
          <a:xfrm>
            <a:off x="4691160" y="371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3T22:16:44Z</dcterms:created>
  <dc:creator>Paul Knoepfler</dc:creator>
  <dc:description/>
  <dc:language>en-US</dc:language>
  <cp:lastModifiedBy>Paul Knoepfler</cp:lastModifiedBy>
  <dcterms:modified xsi:type="dcterms:W3CDTF">2013-03-18T22:01:35Z</dcterms:modified>
  <cp:revision>10</cp:revision>
  <dc:subject/>
  <dc:title>Slide 1</dc:title>
</cp:coreProperties>
</file>